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notesMasterIdLst>
    <p:notesMasterId r:id="rId6"/>
  </p:notesMasterIdLst>
  <p:sldIdLst>
    <p:sldId id="257" r:id="rId5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5015" autoAdjust="0"/>
    <p:restoredTop sz="94680"/>
  </p:normalViewPr>
  <p:slideViewPr>
    <p:cSldViewPr snapToGrid="0">
      <p:cViewPr varScale="1">
        <p:scale>
          <a:sx n="107" d="100"/>
          <a:sy n="107" d="100"/>
        </p:scale>
        <p:origin x="139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E6FDFD7-A418-C44F-B7F2-F1D6F3327D56}" type="datetimeFigureOut">
              <a:rPr lang="it-IT" smtClean="0"/>
              <a:t>07/01/2026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F170CCE-5F0A-E04B-9E9B-C1E751505A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792299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F170CCE-5F0A-E04B-9E9B-C1E751505A65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282459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87AF31B-6A17-BA10-29F9-569C10C73CC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46AC0D4D-789C-3256-4049-C030750BB29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AF954A1-E693-9A93-F27D-3B76E67B36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72737-4312-0141-8BCB-704BC057E4E0}" type="datetimeFigureOut">
              <a:rPr lang="it-IT" smtClean="0"/>
              <a:t>07/01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BA60AAD-FA35-3DA4-8EB4-1D6FD44BF7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E6C7F3A-2C6F-219E-21EB-931EB72D72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517D2-4B6E-1D4A-BFF0-6F2E8EB6879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00470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7026F29-A060-57A8-5953-8ECE3F21D8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9FBD2E34-7EE8-2FD4-A396-74773A1C613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3D7E9A3-A799-FC12-FB6D-7542445CBA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72737-4312-0141-8BCB-704BC057E4E0}" type="datetimeFigureOut">
              <a:rPr lang="it-IT" smtClean="0"/>
              <a:t>07/01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A7791AF-538D-C95E-6CC4-4AC322CE69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59B5704-1774-0F1A-46F0-FE7880ADA4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517D2-4B6E-1D4A-BFF0-6F2E8EB6879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482203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1BCEC339-9E25-B2A1-55FF-13F907172E0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488B70C9-927A-CFF6-06E6-16E79FBBE82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718C896-2662-04FF-2A36-2AED726324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72737-4312-0141-8BCB-704BC057E4E0}" type="datetimeFigureOut">
              <a:rPr lang="it-IT" smtClean="0"/>
              <a:t>07/01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ACB8EE1-FD7C-15FB-D755-4E7DA55785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D3BD243-8254-357E-1B4D-73366E0268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517D2-4B6E-1D4A-BFF0-6F2E8EB6879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799746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3A435D1-44CE-50BF-FD36-A8408B5830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5B52E12-F93A-02FB-A86F-D055BE8D5FE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523C5BB-149D-67EB-D31F-2852DC0A94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72737-4312-0141-8BCB-704BC057E4E0}" type="datetimeFigureOut">
              <a:rPr lang="it-IT" smtClean="0"/>
              <a:t>07/01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06DC07E-E065-BB39-E04E-8DC3C17C59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D996A21-AE6E-EF44-45FD-EFEE21A7C1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517D2-4B6E-1D4A-BFF0-6F2E8EB6879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327001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EF1CC9F-8DA9-7B96-5206-260561122D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FCC1B3DA-125E-F6D0-6C32-5A4C7F70F4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90F9FAB-3F27-5806-85A0-D55CA6F83B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72737-4312-0141-8BCB-704BC057E4E0}" type="datetimeFigureOut">
              <a:rPr lang="it-IT" smtClean="0"/>
              <a:t>07/01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E9B6D40-4E03-B92D-4E2E-D0F164CDEE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F1259AC-D26E-6481-ADF0-6F4D10BC12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517D2-4B6E-1D4A-BFF0-6F2E8EB6879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191243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4C9060C-A47E-9218-3493-949FCE7DD1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8A9BAE7-DF89-5A20-90A0-4E10A9EA32E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9031BF7E-2901-1901-E48E-71F2A2A700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9FCF378-7793-6842-B354-79231B8B3E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72737-4312-0141-8BCB-704BC057E4E0}" type="datetimeFigureOut">
              <a:rPr lang="it-IT" smtClean="0"/>
              <a:t>07/01/2026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22647E28-BD5B-6C22-001F-C0530B810C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EE02B0A2-700E-21EB-11A9-9BD35AE349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517D2-4B6E-1D4A-BFF0-6F2E8EB6879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736101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BB7B828-BA3A-18C2-2B29-5F1F675751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F8254363-8A1D-93B2-8A52-2B6B07F854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9E508016-7ED5-7075-94AC-830C59021F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8359D461-E9C9-2443-3696-8F6DF71B896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CE33B934-FBC6-A5A0-7D32-72E1F3C95F6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2271AA8E-EC28-ECF2-1F96-1ADA34BE1D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72737-4312-0141-8BCB-704BC057E4E0}" type="datetimeFigureOut">
              <a:rPr lang="it-IT" smtClean="0"/>
              <a:t>07/01/2026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3F195902-9B81-B4B3-204E-D8717E57CD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6F007DC4-2452-3E92-E987-6C6A615AAB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517D2-4B6E-1D4A-BFF0-6F2E8EB6879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322184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AD1196A-7033-497F-0949-4D00DE5F93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E01827D5-240B-14ED-DFBF-17232F0180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72737-4312-0141-8BCB-704BC057E4E0}" type="datetimeFigureOut">
              <a:rPr lang="it-IT" smtClean="0"/>
              <a:t>07/01/2026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50C3EBD9-A520-57FC-97A3-E2D0BD0AA5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C6505A14-4D03-9FD2-FA8A-26B2FE3AE1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517D2-4B6E-1D4A-BFF0-6F2E8EB6879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73741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4F1A92C8-F311-9096-29D4-DBFE3BD6E3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72737-4312-0141-8BCB-704BC057E4E0}" type="datetimeFigureOut">
              <a:rPr lang="it-IT" smtClean="0"/>
              <a:t>07/01/2026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C2A59412-9697-1299-D1CD-B46864F683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0A4B29FA-3A96-2135-52BC-54D21B4A10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517D2-4B6E-1D4A-BFF0-6F2E8EB6879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451368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E6F816C-9FCE-AB82-0075-2A4532CB3F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2211662-61AC-2D2F-E4A6-9BC76C99128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98C2550B-3C00-7919-28AB-E99E118B88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BE3EC24-BE97-F179-D8BB-8B7B315990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72737-4312-0141-8BCB-704BC057E4E0}" type="datetimeFigureOut">
              <a:rPr lang="it-IT" smtClean="0"/>
              <a:t>07/01/2026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A40541E-7B78-F91D-A538-3F4182C988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72BEC3D9-2E19-B525-A323-F70281B7E4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517D2-4B6E-1D4A-BFF0-6F2E8EB6879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52647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1524C87-E1B1-6C31-3420-7B7E00B2CE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51658954-FF02-77A1-C8B4-F458AAF37A2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64AD6503-649D-A63A-B842-3B79E80508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B1FD580-002B-78FA-4154-D4745964B3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72737-4312-0141-8BCB-704BC057E4E0}" type="datetimeFigureOut">
              <a:rPr lang="it-IT" smtClean="0"/>
              <a:t>07/01/2026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F972CCA5-298E-1FFD-AB17-D5BCD419CD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58CEB18-3483-60D5-C495-6BE7CC61C3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517D2-4B6E-1D4A-BFF0-6F2E8EB6879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01756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83FD4DD7-8AD2-BA68-7985-BF6670236C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AAF5B2E6-6146-0B17-C840-5902298076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8EBA3A4-9EF8-04F2-8208-52C4516170A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CE72737-4312-0141-8BCB-704BC057E4E0}" type="datetimeFigureOut">
              <a:rPr lang="it-IT" smtClean="0"/>
              <a:t>07/01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CC1BC78-AB5D-0051-214A-3954AC0EC13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FA3D6F8-2561-8861-6790-96F46C097EC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40517D2-4B6E-1D4A-BFF0-6F2E8EB6879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801191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6C7C0638-948D-4940-B7CC-D5999030525F}"/>
              </a:ext>
            </a:extLst>
          </p:cNvPr>
          <p:cNvSpPr txBox="1"/>
          <p:nvPr/>
        </p:nvSpPr>
        <p:spPr>
          <a:xfrm>
            <a:off x="837354" y="0"/>
            <a:ext cx="11043034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000" b="1" dirty="0">
                <a:solidFill>
                  <a:srgbClr val="0E101A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etastatic Extra-Axial Medulloblastoma Involving the Trigeminal Nerve: A Rare Prognostic Entity with a Comprehensive </a:t>
            </a:r>
            <a:r>
              <a:rPr lang="en-US" sz="2000" b="1" dirty="0">
                <a:solidFill>
                  <a:srgbClr val="0E101A"/>
                </a:solidFill>
                <a:latin typeface="Times New Roman" panose="02020603050405020304" pitchFamily="18" charset="0"/>
              </a:rPr>
              <a:t>Literature Review</a:t>
            </a:r>
            <a:endParaRPr lang="it-IT" sz="2000" b="1" dirty="0">
              <a:solidFill>
                <a:srgbClr val="0E101A"/>
              </a:solidFill>
              <a:latin typeface="Times New Roman" panose="02020603050405020304" pitchFamily="18" charset="0"/>
            </a:endParaRP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0553823E-238E-551E-3371-50EE4FAF3F0B}"/>
              </a:ext>
            </a:extLst>
          </p:cNvPr>
          <p:cNvSpPr txBox="1"/>
          <p:nvPr/>
        </p:nvSpPr>
        <p:spPr>
          <a:xfrm>
            <a:off x="201908" y="3635494"/>
            <a:ext cx="2596913" cy="12772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Bs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assified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o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ur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in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bgroups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WNT, SHH, Group 3, and Group 4.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pproximately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-6% are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sociated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ncer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disposition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ndromes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TCH1, SUFU, TP53, and SMO).</a:t>
            </a:r>
            <a:endParaRPr lang="it-IT" sz="1400" dirty="0"/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4D4CB103-9553-00B1-2986-CB0749329D37}"/>
              </a:ext>
            </a:extLst>
          </p:cNvPr>
          <p:cNvSpPr txBox="1"/>
          <p:nvPr/>
        </p:nvSpPr>
        <p:spPr>
          <a:xfrm>
            <a:off x="6185983" y="869923"/>
            <a:ext cx="6097190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his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s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nitial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report of a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ediatric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atient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with a CHEK2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germline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variant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uncertain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ignificance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The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atient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eveloped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an extra-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xial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medulloblastoma (EA-MB)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t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rigeminal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erve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The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isease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rogressed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apidly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leading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oth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entral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ervous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system (CNS)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etastases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and extra-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eural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etastases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(ENM)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espite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treatment with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hemo-radiotherapy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Immagine 11" descr="Immagine che contiene Materiale trasparente, liquido, bianco e nero, monocromatico&#10;&#10;Descrizione generata automaticamente">
            <a:extLst>
              <a:ext uri="{FF2B5EF4-FFF2-40B4-BE49-F238E27FC236}">
                <a16:creationId xmlns:a16="http://schemas.microsoft.com/office/drawing/2014/main" id="{FC5CED28-3FAC-0A04-4688-EE06114521DE}"/>
              </a:ext>
            </a:extLst>
          </p:cNvPr>
          <p:cNvPicPr>
            <a:picLocks noChangeAspect="1"/>
          </p:cNvPicPr>
          <p:nvPr/>
        </p:nvPicPr>
        <p:blipFill>
          <a:blip r:embed="rId3">
            <a:duotone>
              <a:prstClr val="black"/>
              <a:srgbClr val="D9C3A5">
                <a:tint val="50000"/>
                <a:satMod val="180000"/>
              </a:srgbClr>
            </a:duotone>
          </a:blip>
          <a:srcRect l="7713" t="3014" r="4158"/>
          <a:stretch/>
        </p:blipFill>
        <p:spPr>
          <a:xfrm>
            <a:off x="7930916" y="1685408"/>
            <a:ext cx="1293142" cy="1267392"/>
          </a:xfrm>
          <a:prstGeom prst="rect">
            <a:avLst/>
          </a:prstGeom>
        </p:spPr>
      </p:pic>
      <p:pic>
        <p:nvPicPr>
          <p:cNvPr id="13" name="Immagine 12" descr="Immagine che contiene Imaging medicale, radiologia, bianco e nero, monocromatico&#10;&#10;Descrizione generata automaticamente">
            <a:extLst>
              <a:ext uri="{FF2B5EF4-FFF2-40B4-BE49-F238E27FC236}">
                <a16:creationId xmlns:a16="http://schemas.microsoft.com/office/drawing/2014/main" id="{A53EDA11-383C-F395-3B4D-AA6C57F7FE9F}"/>
              </a:ext>
            </a:extLst>
          </p:cNvPr>
          <p:cNvPicPr>
            <a:picLocks noChangeAspect="1"/>
          </p:cNvPicPr>
          <p:nvPr/>
        </p:nvPicPr>
        <p:blipFill>
          <a:blip r:embed="rId4">
            <a:duotone>
              <a:prstClr val="black"/>
              <a:srgbClr val="D9C3A5">
                <a:tint val="50000"/>
                <a:satMod val="180000"/>
              </a:srgbClr>
            </a:duotone>
          </a:blip>
          <a:srcRect l="4547"/>
          <a:stretch/>
        </p:blipFill>
        <p:spPr>
          <a:xfrm>
            <a:off x="9234578" y="1688111"/>
            <a:ext cx="1404081" cy="1267392"/>
          </a:xfrm>
          <a:prstGeom prst="rect">
            <a:avLst/>
          </a:prstGeom>
        </p:spPr>
      </p:pic>
      <p:pic>
        <p:nvPicPr>
          <p:cNvPr id="15" name="Immagine 14" descr="Immagine che contiene schizzo, disegno, arte, illustrazione&#10;&#10;Descrizione generata automaticamente">
            <a:extLst>
              <a:ext uri="{FF2B5EF4-FFF2-40B4-BE49-F238E27FC236}">
                <a16:creationId xmlns:a16="http://schemas.microsoft.com/office/drawing/2014/main" id="{8EBCAB14-B6B5-7A69-9DE6-B41599C86D0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42497" y="2304009"/>
            <a:ext cx="1916357" cy="1435312"/>
          </a:xfrm>
          <a:prstGeom prst="rect">
            <a:avLst/>
          </a:prstGeom>
        </p:spPr>
      </p:pic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16D3AA62-7A66-C31F-E5DF-558F8936D5CB}"/>
              </a:ext>
            </a:extLst>
          </p:cNvPr>
          <p:cNvSpPr txBox="1"/>
          <p:nvPr/>
        </p:nvSpPr>
        <p:spPr>
          <a:xfrm>
            <a:off x="297620" y="1155618"/>
            <a:ext cx="2596913" cy="10464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dulloblastomas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Bs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re the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st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mmon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lignant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NS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mors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diatric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tients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imarily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veloping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rebellar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rmis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urth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ntricle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endParaRPr lang="it-IT" dirty="0"/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AC84025B-6B23-3DB4-EF25-518F7DE46A36}"/>
              </a:ext>
            </a:extLst>
          </p:cNvPr>
          <p:cNvSpPr txBox="1"/>
          <p:nvPr/>
        </p:nvSpPr>
        <p:spPr>
          <a:xfrm>
            <a:off x="3459402" y="1185344"/>
            <a:ext cx="2546616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y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rely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ise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utside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brain and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inal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rd (extra-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xial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nd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hile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st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astases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ccur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in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CNS, extra-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ural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astases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 rare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agnosis. 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D3CCEDCE-4023-A2B2-38A3-5511D5A00677}"/>
              </a:ext>
            </a:extLst>
          </p:cNvPr>
          <p:cNvSpPr txBox="1"/>
          <p:nvPr/>
        </p:nvSpPr>
        <p:spPr>
          <a:xfrm>
            <a:off x="775934" y="6053832"/>
            <a:ext cx="10612736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ke-Home Message</a:t>
            </a:r>
          </a:p>
          <a:p>
            <a:pPr algn="ctr"/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eterogeneity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of medulloblastoma (MB) underscores the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ritical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eed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for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mproved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iagnostic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ethods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ersonalized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treatment plans.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ontinued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dvancements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olecular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profiling and treatment strategies are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rucial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for the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ffective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management of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his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omplex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hallenging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isease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3792791B-AB3F-3A7B-41DC-F939B96C266C}"/>
              </a:ext>
            </a:extLst>
          </p:cNvPr>
          <p:cNvSpPr txBox="1"/>
          <p:nvPr/>
        </p:nvSpPr>
        <p:spPr>
          <a:xfrm>
            <a:off x="1274175" y="5423265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it-IT" dirty="0"/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B4F7199E-4F06-8B94-0489-C5C5AEC7A327}"/>
              </a:ext>
            </a:extLst>
          </p:cNvPr>
          <p:cNvSpPr txBox="1"/>
          <p:nvPr/>
        </p:nvSpPr>
        <p:spPr>
          <a:xfrm>
            <a:off x="3479588" y="3805346"/>
            <a:ext cx="2530904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spite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dvancements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ltimodal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rapies,  high-risk MB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tients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ounger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an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ears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with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btotal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section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astases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agnosis)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ve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nly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 30% </a:t>
            </a:r>
            <a:r>
              <a:rPr lang="it-IT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ve-year</a:t>
            </a:r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rvival rate. </a:t>
            </a:r>
          </a:p>
        </p:txBody>
      </p:sp>
      <p:pic>
        <p:nvPicPr>
          <p:cNvPr id="24" name="Immagine 23">
            <a:extLst>
              <a:ext uri="{FF2B5EF4-FFF2-40B4-BE49-F238E27FC236}">
                <a16:creationId xmlns:a16="http://schemas.microsoft.com/office/drawing/2014/main" id="{4AC15980-3CB3-3A71-3A9D-484216139F40}"/>
              </a:ext>
            </a:extLst>
          </p:cNvPr>
          <p:cNvPicPr>
            <a:picLocks noChangeAspect="1"/>
          </p:cNvPicPr>
          <p:nvPr/>
        </p:nvPicPr>
        <p:blipFill>
          <a:blip r:embed="rId6">
            <a:duotone>
              <a:prstClr val="black"/>
              <a:srgbClr val="D9C3A5">
                <a:tint val="50000"/>
                <a:satMod val="180000"/>
              </a:srgbClr>
            </a:duotone>
          </a:blip>
          <a:stretch>
            <a:fillRect/>
          </a:stretch>
        </p:blipFill>
        <p:spPr>
          <a:xfrm>
            <a:off x="8532537" y="2977724"/>
            <a:ext cx="1404082" cy="1225285"/>
          </a:xfrm>
          <a:prstGeom prst="rect">
            <a:avLst/>
          </a:prstGeom>
        </p:spPr>
      </p:pic>
      <p:sp>
        <p:nvSpPr>
          <p:cNvPr id="6" name="Isosceles Triangle 5">
            <a:extLst>
              <a:ext uri="{FF2B5EF4-FFF2-40B4-BE49-F238E27FC236}">
                <a16:creationId xmlns:a16="http://schemas.microsoft.com/office/drawing/2014/main" id="{91D52CA7-D5D1-0C6E-705D-48E0A5595659}"/>
              </a:ext>
            </a:extLst>
          </p:cNvPr>
          <p:cNvSpPr/>
          <p:nvPr/>
        </p:nvSpPr>
        <p:spPr>
          <a:xfrm rot="7647264">
            <a:off x="3667134" y="3241735"/>
            <a:ext cx="645349" cy="413687"/>
          </a:xfrm>
          <a:prstGeom prst="triangle">
            <a:avLst>
              <a:gd name="adj" fmla="val 52167"/>
            </a:avLst>
          </a:prstGeom>
          <a:solidFill>
            <a:schemeClr val="tx2">
              <a:lumMod val="10000"/>
              <a:lumOff val="9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Isosceles Triangle 6">
            <a:extLst>
              <a:ext uri="{FF2B5EF4-FFF2-40B4-BE49-F238E27FC236}">
                <a16:creationId xmlns:a16="http://schemas.microsoft.com/office/drawing/2014/main" id="{548A4F03-4E2E-E71F-5150-1A33EFED4557}"/>
              </a:ext>
            </a:extLst>
          </p:cNvPr>
          <p:cNvSpPr/>
          <p:nvPr/>
        </p:nvSpPr>
        <p:spPr>
          <a:xfrm rot="3229718">
            <a:off x="3494147" y="2204377"/>
            <a:ext cx="645349" cy="413687"/>
          </a:xfrm>
          <a:prstGeom prst="triangle">
            <a:avLst>
              <a:gd name="adj" fmla="val 52167"/>
            </a:avLst>
          </a:prstGeom>
          <a:solidFill>
            <a:schemeClr val="tx2">
              <a:lumMod val="10000"/>
              <a:lumOff val="9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Isosceles Triangle 7">
            <a:extLst>
              <a:ext uri="{FF2B5EF4-FFF2-40B4-BE49-F238E27FC236}">
                <a16:creationId xmlns:a16="http://schemas.microsoft.com/office/drawing/2014/main" id="{0E17F573-D478-C71E-C81B-77255B096A81}"/>
              </a:ext>
            </a:extLst>
          </p:cNvPr>
          <p:cNvSpPr/>
          <p:nvPr/>
        </p:nvSpPr>
        <p:spPr>
          <a:xfrm rot="18587198">
            <a:off x="1711714" y="2145158"/>
            <a:ext cx="645349" cy="413687"/>
          </a:xfrm>
          <a:prstGeom prst="triangle">
            <a:avLst>
              <a:gd name="adj" fmla="val 52167"/>
            </a:avLst>
          </a:prstGeom>
          <a:solidFill>
            <a:schemeClr val="tx2">
              <a:lumMod val="10000"/>
              <a:lumOff val="9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Isosceles Triangle 9">
            <a:extLst>
              <a:ext uri="{FF2B5EF4-FFF2-40B4-BE49-F238E27FC236}">
                <a16:creationId xmlns:a16="http://schemas.microsoft.com/office/drawing/2014/main" id="{95B853BA-E687-9ED8-CC8D-5D5FF1FFED97}"/>
              </a:ext>
            </a:extLst>
          </p:cNvPr>
          <p:cNvSpPr/>
          <p:nvPr/>
        </p:nvSpPr>
        <p:spPr>
          <a:xfrm rot="14032009">
            <a:off x="1719822" y="3259924"/>
            <a:ext cx="645349" cy="413687"/>
          </a:xfrm>
          <a:prstGeom prst="triangle">
            <a:avLst>
              <a:gd name="adj" fmla="val 52167"/>
            </a:avLst>
          </a:prstGeom>
          <a:solidFill>
            <a:schemeClr val="tx2">
              <a:lumMod val="10000"/>
              <a:lumOff val="9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12EEF51D-0856-B719-C396-8718048B3A6B}"/>
              </a:ext>
            </a:extLst>
          </p:cNvPr>
          <p:cNvCxnSpPr/>
          <p:nvPr/>
        </p:nvCxnSpPr>
        <p:spPr>
          <a:xfrm>
            <a:off x="6006019" y="966651"/>
            <a:ext cx="0" cy="4356000"/>
          </a:xfrm>
          <a:prstGeom prst="line">
            <a:avLst/>
          </a:prstGeom>
          <a:ln w="6350"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Isosceles Triangle 19">
            <a:extLst>
              <a:ext uri="{FF2B5EF4-FFF2-40B4-BE49-F238E27FC236}">
                <a16:creationId xmlns:a16="http://schemas.microsoft.com/office/drawing/2014/main" id="{89256C0E-56DC-451A-A054-3018B46CAFCC}"/>
              </a:ext>
            </a:extLst>
          </p:cNvPr>
          <p:cNvSpPr/>
          <p:nvPr/>
        </p:nvSpPr>
        <p:spPr>
          <a:xfrm rot="10800000">
            <a:off x="5169098" y="5495250"/>
            <a:ext cx="1673837" cy="374254"/>
          </a:xfrm>
          <a:prstGeom prst="triangle">
            <a:avLst/>
          </a:prstGeom>
          <a:solidFill>
            <a:schemeClr val="accent6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CasellaDiTesto 25">
            <a:extLst>
              <a:ext uri="{FF2B5EF4-FFF2-40B4-BE49-F238E27FC236}">
                <a16:creationId xmlns:a16="http://schemas.microsoft.com/office/drawing/2014/main" id="{525D905A-CA6F-2047-16BE-B61015181C85}"/>
              </a:ext>
            </a:extLst>
          </p:cNvPr>
          <p:cNvSpPr txBox="1"/>
          <p:nvPr/>
        </p:nvSpPr>
        <p:spPr>
          <a:xfrm>
            <a:off x="6119894" y="4379770"/>
            <a:ext cx="5995223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ore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han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36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rticles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ave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ocumented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rimary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extra-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xial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edulloblastomas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Bs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in the literature. </a:t>
            </a:r>
          </a:p>
          <a:p>
            <a:endParaRPr lang="it-IT" sz="1100" b="0" i="0" dirty="0">
              <a:solidFill>
                <a:srgbClr val="1C1C1C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here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are </a:t>
            </a:r>
            <a:r>
              <a:rPr lang="it-IT" sz="1100" b="1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o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eported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ases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pecifically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nvolving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rigeminal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erve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nly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our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ases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young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dults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with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typical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eratoid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habdoid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umors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ther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major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umors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riginating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from the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rigeminal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erve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ave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een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100" b="0" i="0" dirty="0" err="1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ecorded</a:t>
            </a:r>
            <a:r>
              <a:rPr lang="it-IT" sz="1100" b="0" i="0" dirty="0">
                <a:solidFill>
                  <a:srgbClr val="1C1C1C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8585596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0340f064-47bd-43bf-a077-c7a95db99d02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6C76DD9CAB4D1449D6C1492FE03181D" ma:contentTypeVersion="17" ma:contentTypeDescription="Create a new document." ma:contentTypeScope="" ma:versionID="0fc875cf3f8ddefad2c373116e096257">
  <xsd:schema xmlns:xsd="http://www.w3.org/2001/XMLSchema" xmlns:xs="http://www.w3.org/2001/XMLSchema" xmlns:p="http://schemas.microsoft.com/office/2006/metadata/properties" xmlns:ns3="0340f064-47bd-43bf-a077-c7a95db99d02" xmlns:ns4="a5913304-1e0f-4a9b-828d-533272a1211b" targetNamespace="http://schemas.microsoft.com/office/2006/metadata/properties" ma:root="true" ma:fieldsID="4803fe812d41d5108567370a5ce21474" ns3:_="" ns4:_="">
    <xsd:import namespace="0340f064-47bd-43bf-a077-c7a95db99d02"/>
    <xsd:import namespace="a5913304-1e0f-4a9b-828d-533272a1211b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  <xsd:element ref="ns3:MediaServiceAutoKeyPoints" minOccurs="0"/>
                <xsd:element ref="ns3:MediaServiceKeyPoints" minOccurs="0"/>
                <xsd:element ref="ns3:MediaServiceLocation" minOccurs="0"/>
                <xsd:element ref="ns3:_activity" minOccurs="0"/>
                <xsd:element ref="ns3:MediaServiceObjectDetectorVersion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340f064-47bd-43bf-a077-c7a95db99d0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8" nillable="true" ma:displayName="Length (seconds)" ma:internalName="MediaLengthInSeconds" ma:readOnly="true">
      <xsd:simpleType>
        <xsd:restriction base="dms:Unknown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Location" ma:index="21" nillable="true" ma:displayName="Location" ma:internalName="MediaServiceLocation" ma:readOnly="true">
      <xsd:simpleType>
        <xsd:restriction base="dms:Text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5913304-1e0f-4a9b-828d-533272a1211b" elementFormDefault="qualified">
    <xsd:import namespace="http://schemas.microsoft.com/office/2006/documentManagement/types"/>
    <xsd:import namespace="http://schemas.microsoft.com/office/infopath/2007/PartnerControls"/>
    <xsd:element name="SharedWithUsers" ma:index="15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6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7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5C564017-D8EC-411F-858C-D1AD5ED297DE}">
  <ds:schemaRefs>
    <ds:schemaRef ds:uri="http://purl.org/dc/dcmitype/"/>
    <ds:schemaRef ds:uri="a5913304-1e0f-4a9b-828d-533272a1211b"/>
    <ds:schemaRef ds:uri="http://schemas.microsoft.com/office/infopath/2007/PartnerControls"/>
    <ds:schemaRef ds:uri="http://www.w3.org/XML/1998/namespace"/>
    <ds:schemaRef ds:uri="http://purl.org/dc/terms/"/>
    <ds:schemaRef ds:uri="http://schemas.microsoft.com/office/2006/documentManagement/types"/>
    <ds:schemaRef ds:uri="0340f064-47bd-43bf-a077-c7a95db99d02"/>
    <ds:schemaRef ds:uri="http://schemas.openxmlformats.org/package/2006/metadata/core-properties"/>
    <ds:schemaRef ds:uri="http://schemas.microsoft.com/office/2006/metadata/properties"/>
    <ds:schemaRef ds:uri="http://purl.org/dc/elements/1.1/"/>
  </ds:schemaRefs>
</ds:datastoreItem>
</file>

<file path=customXml/itemProps2.xml><?xml version="1.0" encoding="utf-8"?>
<ds:datastoreItem xmlns:ds="http://schemas.openxmlformats.org/officeDocument/2006/customXml" ds:itemID="{A262ECC6-026E-446C-92C9-82A63EC6B2B6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340f064-47bd-43bf-a077-c7a95db99d02"/>
    <ds:schemaRef ds:uri="a5913304-1e0f-4a9b-828d-533272a1211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C6E6EA2D-60A7-4D20-9684-9DF26EDF20C9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41</TotalTime>
  <Words>294</Words>
  <Application>Microsoft Office PowerPoint</Application>
  <PresentationFormat>Widescreen</PresentationFormat>
  <Paragraphs>13</Paragraphs>
  <Slides>1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ederica d antonio</dc:creator>
  <cp:lastModifiedBy>Megaro Giacomina</cp:lastModifiedBy>
  <cp:revision>6</cp:revision>
  <dcterms:created xsi:type="dcterms:W3CDTF">2024-10-09T04:38:53Z</dcterms:created>
  <dcterms:modified xsi:type="dcterms:W3CDTF">2026-01-07T17:12:4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ea60d57e-af5b-4752-ac57-3e4f28ca11dc_Enabled">
    <vt:lpwstr>true</vt:lpwstr>
  </property>
  <property fmtid="{D5CDD505-2E9C-101B-9397-08002B2CF9AE}" pid="3" name="MSIP_Label_ea60d57e-af5b-4752-ac57-3e4f28ca11dc_SetDate">
    <vt:lpwstr>2024-10-09T07:33:10Z</vt:lpwstr>
  </property>
  <property fmtid="{D5CDD505-2E9C-101B-9397-08002B2CF9AE}" pid="4" name="MSIP_Label_ea60d57e-af5b-4752-ac57-3e4f28ca11dc_Method">
    <vt:lpwstr>Standard</vt:lpwstr>
  </property>
  <property fmtid="{D5CDD505-2E9C-101B-9397-08002B2CF9AE}" pid="5" name="MSIP_Label_ea60d57e-af5b-4752-ac57-3e4f28ca11dc_Name">
    <vt:lpwstr>ea60d57e-af5b-4752-ac57-3e4f28ca11dc</vt:lpwstr>
  </property>
  <property fmtid="{D5CDD505-2E9C-101B-9397-08002B2CF9AE}" pid="6" name="MSIP_Label_ea60d57e-af5b-4752-ac57-3e4f28ca11dc_SiteId">
    <vt:lpwstr>36da45f1-dd2c-4d1f-af13-5abe46b99921</vt:lpwstr>
  </property>
  <property fmtid="{D5CDD505-2E9C-101B-9397-08002B2CF9AE}" pid="7" name="MSIP_Label_ea60d57e-af5b-4752-ac57-3e4f28ca11dc_ActionId">
    <vt:lpwstr>a2313984-698b-4b4a-b974-f2b6720322ba</vt:lpwstr>
  </property>
  <property fmtid="{D5CDD505-2E9C-101B-9397-08002B2CF9AE}" pid="8" name="MSIP_Label_ea60d57e-af5b-4752-ac57-3e4f28ca11dc_ContentBits">
    <vt:lpwstr>0</vt:lpwstr>
  </property>
  <property fmtid="{D5CDD505-2E9C-101B-9397-08002B2CF9AE}" pid="9" name="ContentTypeId">
    <vt:lpwstr>0x01010026C76DD9CAB4D1449D6C1492FE03181D</vt:lpwstr>
  </property>
</Properties>
</file>